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400800" cy="731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9" d="100"/>
          <a:sy n="89" d="100"/>
        </p:scale>
        <p:origin x="-2872" y="-120"/>
      </p:cViewPr>
      <p:guideLst>
        <p:guide orient="horz" pos="2304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272455"/>
            <a:ext cx="5440680" cy="15680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145280"/>
            <a:ext cx="4480560" cy="18694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098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550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0580" y="292949"/>
            <a:ext cx="1440180" cy="624162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0040" y="292949"/>
            <a:ext cx="4213860" cy="624162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084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731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4700694"/>
            <a:ext cx="5440680" cy="14528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100495"/>
            <a:ext cx="5440680" cy="16001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683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0040" y="1706880"/>
            <a:ext cx="2827020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53740" y="1706880"/>
            <a:ext cx="2827020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01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1" y="1637455"/>
            <a:ext cx="2828132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1" y="2319868"/>
            <a:ext cx="2828132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637455"/>
            <a:ext cx="2829243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319868"/>
            <a:ext cx="2829243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766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998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501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291253"/>
            <a:ext cx="2105819" cy="123952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291255"/>
            <a:ext cx="3578225" cy="62433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530775"/>
            <a:ext cx="2105819" cy="50038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144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120641"/>
            <a:ext cx="3840480" cy="60452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653627"/>
            <a:ext cx="3840480" cy="43891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5725162"/>
            <a:ext cx="3840480" cy="8585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811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292947"/>
            <a:ext cx="5760720" cy="121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706880"/>
            <a:ext cx="5760720" cy="48276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6780108"/>
            <a:ext cx="149352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05DBE1-BC05-3641-B077-98C43E5F0CFB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6780108"/>
            <a:ext cx="202692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6780108"/>
            <a:ext cx="149352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CDA3E-3522-7445-A5A9-4B14B2D47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68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Picture 1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793" y="31940"/>
            <a:ext cx="3200400" cy="6858000"/>
          </a:xfrm>
          <a:prstGeom prst="rect">
            <a:avLst/>
          </a:prstGeom>
        </p:spPr>
      </p:pic>
      <p:pic>
        <p:nvPicPr>
          <p:cNvPr id="143" name="Picture 14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43554" y="48324"/>
            <a:ext cx="1828800" cy="6858000"/>
          </a:xfrm>
          <a:prstGeom prst="rect">
            <a:avLst/>
          </a:prstGeom>
        </p:spPr>
      </p:pic>
      <p:sp>
        <p:nvSpPr>
          <p:cNvPr id="144" name="TextBox 143"/>
          <p:cNvSpPr txBox="1"/>
          <p:nvPr/>
        </p:nvSpPr>
        <p:spPr>
          <a:xfrm rot="5400000">
            <a:off x="3260706" y="112503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1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5" name="TextBox 144"/>
          <p:cNvSpPr txBox="1"/>
          <p:nvPr/>
        </p:nvSpPr>
        <p:spPr>
          <a:xfrm rot="5400000">
            <a:off x="3264745" y="684878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2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6" name="TextBox 145"/>
          <p:cNvSpPr txBox="1"/>
          <p:nvPr/>
        </p:nvSpPr>
        <p:spPr>
          <a:xfrm rot="5400000">
            <a:off x="3264748" y="1260029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3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7" name="TextBox 146"/>
          <p:cNvSpPr txBox="1"/>
          <p:nvPr/>
        </p:nvSpPr>
        <p:spPr>
          <a:xfrm rot="5400000">
            <a:off x="3264748" y="1823309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8" name="TextBox 147"/>
          <p:cNvSpPr txBox="1"/>
          <p:nvPr/>
        </p:nvSpPr>
        <p:spPr>
          <a:xfrm rot="5400000">
            <a:off x="3264748" y="2395288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5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9" name="TextBox 148"/>
          <p:cNvSpPr txBox="1"/>
          <p:nvPr/>
        </p:nvSpPr>
        <p:spPr>
          <a:xfrm rot="5400000">
            <a:off x="3264748" y="2980499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6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0" name="TextBox 149"/>
          <p:cNvSpPr txBox="1"/>
          <p:nvPr/>
        </p:nvSpPr>
        <p:spPr>
          <a:xfrm rot="5400000">
            <a:off x="3264748" y="3549958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7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1" name="TextBox 150"/>
          <p:cNvSpPr txBox="1"/>
          <p:nvPr/>
        </p:nvSpPr>
        <p:spPr>
          <a:xfrm rot="5400000">
            <a:off x="3265050" y="4124633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8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2" name="TextBox 151"/>
          <p:cNvSpPr txBox="1"/>
          <p:nvPr/>
        </p:nvSpPr>
        <p:spPr>
          <a:xfrm rot="5400000">
            <a:off x="3264748" y="4695906"/>
            <a:ext cx="696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9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3" name="TextBox 152"/>
          <p:cNvSpPr txBox="1"/>
          <p:nvPr/>
        </p:nvSpPr>
        <p:spPr>
          <a:xfrm rot="5400000">
            <a:off x="3168168" y="5246876"/>
            <a:ext cx="889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1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4" name="TextBox 153"/>
          <p:cNvSpPr txBox="1"/>
          <p:nvPr/>
        </p:nvSpPr>
        <p:spPr>
          <a:xfrm rot="5400000">
            <a:off x="3168167" y="5852530"/>
            <a:ext cx="889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11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5" name="TextBox 154"/>
          <p:cNvSpPr txBox="1"/>
          <p:nvPr/>
        </p:nvSpPr>
        <p:spPr>
          <a:xfrm rot="5400000">
            <a:off x="3168166" y="6437348"/>
            <a:ext cx="889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Chr12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242398" y="277764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87653" y="-78216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42398" y="85604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87653" y="50006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242398" y="1423584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187653" y="1067604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242398" y="1981352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187653" y="1625372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242398" y="256842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187653" y="221244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242398" y="3135421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187653" y="2779441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242398" y="370295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187653" y="334697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242398" y="4275436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187653" y="3919456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242398" y="4842430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187653" y="4486450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242398" y="5419736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187653" y="5063756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242398" y="5996499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187653" y="5640519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242398" y="657025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187653" y="621427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1.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496349" y="6750713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1127834" y="6750713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1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1726498" y="6750713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2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2328283" y="6750713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3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2935148" y="6750713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4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0" y="6977627"/>
            <a:ext cx="41435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Basmati 334 </a:t>
            </a:r>
            <a:r>
              <a:rPr lang="en-US" sz="1600" dirty="0" smtClean="0">
                <a:latin typeface="Helvetica"/>
                <a:cs typeface="Helvetica"/>
              </a:rPr>
              <a:t>chromosomal Position (</a:t>
            </a:r>
            <a:r>
              <a:rPr lang="en-US" sz="1600" dirty="0" err="1" smtClean="0">
                <a:latin typeface="Helvetica"/>
                <a:cs typeface="Helvetica"/>
              </a:rPr>
              <a:t>Mbp</a:t>
            </a:r>
            <a:r>
              <a:rPr lang="en-US" sz="1600" dirty="0" smtClean="0">
                <a:latin typeface="Helvetica"/>
                <a:cs typeface="Helvetica"/>
              </a:rPr>
              <a:t>)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6" name="TextBox 185"/>
          <p:cNvSpPr txBox="1"/>
          <p:nvPr/>
        </p:nvSpPr>
        <p:spPr>
          <a:xfrm rot="5400000" flipH="1">
            <a:off x="4663465" y="3201789"/>
            <a:ext cx="27641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Average Topology Weight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3814665" y="296945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3759920" y="-34375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3814665" y="88755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3759920" y="58089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3814665" y="1467425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3759920" y="1136105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 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3814665" y="2025193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3759920" y="1669213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3814665" y="261226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3759920" y="2256288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3814665" y="3179262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3759920" y="2823282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3814665" y="3746799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3759920" y="3390819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3814665" y="431927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3759920" y="396329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3814665" y="4886271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3759920" y="4530291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3814665" y="546357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3759920" y="5107597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3814665" y="6040340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3759920" y="5684360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3814665" y="6614099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  0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3759920" y="6258119"/>
            <a:ext cx="558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/>
                <a:cs typeface="Helvetica"/>
              </a:rPr>
              <a:t> </a:t>
            </a:r>
            <a:r>
              <a:rPr lang="en-US" sz="1600" dirty="0" smtClean="0">
                <a:latin typeface="Helvetica"/>
                <a:cs typeface="Helvetica"/>
              </a:rPr>
              <a:t>0.4</a:t>
            </a:r>
            <a:endParaRPr lang="en-US" sz="16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4134229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24</Words>
  <Application>Microsoft Macintosh PowerPoint</Application>
  <PresentationFormat>Custom</PresentationFormat>
  <Paragraphs>6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e Young Choi</dc:creator>
  <cp:lastModifiedBy>Jae Young Choi</cp:lastModifiedBy>
  <cp:revision>4</cp:revision>
  <dcterms:created xsi:type="dcterms:W3CDTF">2019-07-08T20:11:00Z</dcterms:created>
  <dcterms:modified xsi:type="dcterms:W3CDTF">2019-07-17T19:38:54Z</dcterms:modified>
</cp:coreProperties>
</file>